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661" r:id="rId2"/>
    <p:sldId id="654" r:id="rId3"/>
    <p:sldId id="6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A488322-F2BA-4B5B-9748-0D474271808F}" styleName="中度样式 3 - 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46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47"/>
            </a:lvl1pPr>
            <a:lvl2pPr marL="351922" indent="0" algn="ctr">
              <a:buNone/>
              <a:defRPr sz="1539"/>
            </a:lvl2pPr>
            <a:lvl3pPr marL="703844" indent="0" algn="ctr">
              <a:buNone/>
              <a:defRPr sz="1386"/>
            </a:lvl3pPr>
            <a:lvl4pPr marL="1055766" indent="0" algn="ctr">
              <a:buNone/>
              <a:defRPr sz="1233"/>
            </a:lvl4pPr>
            <a:lvl5pPr marL="1407688" indent="0" algn="ctr">
              <a:buNone/>
              <a:defRPr sz="1233"/>
            </a:lvl5pPr>
            <a:lvl6pPr marL="1759610" indent="0" algn="ctr">
              <a:buNone/>
              <a:defRPr sz="1233"/>
            </a:lvl6pPr>
            <a:lvl7pPr marL="2111532" indent="0" algn="ctr">
              <a:buNone/>
              <a:defRPr sz="1233"/>
            </a:lvl7pPr>
            <a:lvl8pPr marL="2463455" indent="0" algn="ctr">
              <a:buNone/>
              <a:defRPr sz="1233"/>
            </a:lvl8pPr>
            <a:lvl9pPr marL="2815377" indent="0" algn="ctr">
              <a:buNone/>
              <a:defRPr sz="12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265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2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2907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5147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6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1847">
                <a:solidFill>
                  <a:schemeClr val="tx1"/>
                </a:solidFill>
              </a:defRPr>
            </a:lvl1pPr>
            <a:lvl2pPr marL="351922" indent="0">
              <a:buNone/>
              <a:defRPr sz="1539">
                <a:solidFill>
                  <a:schemeClr val="tx1">
                    <a:tint val="75000"/>
                  </a:schemeClr>
                </a:solidFill>
              </a:defRPr>
            </a:lvl2pPr>
            <a:lvl3pPr marL="70384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3pPr>
            <a:lvl4pPr marL="1055766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4pPr>
            <a:lvl5pPr marL="1407688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5pPr>
            <a:lvl6pPr marL="1759610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6pPr>
            <a:lvl7pPr marL="2111532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7pPr>
            <a:lvl8pPr marL="2463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8pPr>
            <a:lvl9pPr marL="2815377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4150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6291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1847" b="1"/>
            </a:lvl1pPr>
            <a:lvl2pPr marL="351922" indent="0">
              <a:buNone/>
              <a:defRPr sz="1539" b="1"/>
            </a:lvl2pPr>
            <a:lvl3pPr marL="703844" indent="0">
              <a:buNone/>
              <a:defRPr sz="1386" b="1"/>
            </a:lvl3pPr>
            <a:lvl4pPr marL="1055766" indent="0">
              <a:buNone/>
              <a:defRPr sz="1233" b="1"/>
            </a:lvl4pPr>
            <a:lvl5pPr marL="1407688" indent="0">
              <a:buNone/>
              <a:defRPr sz="1233" b="1"/>
            </a:lvl5pPr>
            <a:lvl6pPr marL="1759610" indent="0">
              <a:buNone/>
              <a:defRPr sz="1233" b="1"/>
            </a:lvl6pPr>
            <a:lvl7pPr marL="2111532" indent="0">
              <a:buNone/>
              <a:defRPr sz="1233" b="1"/>
            </a:lvl7pPr>
            <a:lvl8pPr marL="2463455" indent="0">
              <a:buNone/>
              <a:defRPr sz="1233" b="1"/>
            </a:lvl8pPr>
            <a:lvl9pPr marL="2815377" indent="0">
              <a:buNone/>
              <a:defRPr sz="12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47" b="1"/>
            </a:lvl1pPr>
            <a:lvl2pPr marL="351922" indent="0">
              <a:buNone/>
              <a:defRPr sz="1539" b="1"/>
            </a:lvl2pPr>
            <a:lvl3pPr marL="703844" indent="0">
              <a:buNone/>
              <a:defRPr sz="1386" b="1"/>
            </a:lvl3pPr>
            <a:lvl4pPr marL="1055766" indent="0">
              <a:buNone/>
              <a:defRPr sz="1233" b="1"/>
            </a:lvl4pPr>
            <a:lvl5pPr marL="1407688" indent="0">
              <a:buNone/>
              <a:defRPr sz="1233" b="1"/>
            </a:lvl5pPr>
            <a:lvl6pPr marL="1759610" indent="0">
              <a:buNone/>
              <a:defRPr sz="1233" b="1"/>
            </a:lvl6pPr>
            <a:lvl7pPr marL="2111532" indent="0">
              <a:buNone/>
              <a:defRPr sz="1233" b="1"/>
            </a:lvl7pPr>
            <a:lvl8pPr marL="2463455" indent="0">
              <a:buNone/>
              <a:defRPr sz="1233" b="1"/>
            </a:lvl8pPr>
            <a:lvl9pPr marL="2815377" indent="0">
              <a:buNone/>
              <a:defRPr sz="12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3535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582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338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246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62"/>
            </a:lvl1pPr>
            <a:lvl2pPr>
              <a:defRPr sz="2156"/>
            </a:lvl2pPr>
            <a:lvl3pPr>
              <a:defRPr sz="1847"/>
            </a:lvl3pPr>
            <a:lvl4pPr>
              <a:defRPr sz="1539"/>
            </a:lvl4pPr>
            <a:lvl5pPr>
              <a:defRPr sz="1539"/>
            </a:lvl5pPr>
            <a:lvl6pPr>
              <a:defRPr sz="1539"/>
            </a:lvl6pPr>
            <a:lvl7pPr>
              <a:defRPr sz="1539"/>
            </a:lvl7pPr>
            <a:lvl8pPr>
              <a:defRPr sz="1539"/>
            </a:lvl8pPr>
            <a:lvl9pPr>
              <a:defRPr sz="15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233"/>
            </a:lvl1pPr>
            <a:lvl2pPr marL="351922" indent="0">
              <a:buNone/>
              <a:defRPr sz="1077"/>
            </a:lvl2pPr>
            <a:lvl3pPr marL="703844" indent="0">
              <a:buNone/>
              <a:defRPr sz="924"/>
            </a:lvl3pPr>
            <a:lvl4pPr marL="1055766" indent="0">
              <a:buNone/>
              <a:defRPr sz="771"/>
            </a:lvl4pPr>
            <a:lvl5pPr marL="1407688" indent="0">
              <a:buNone/>
              <a:defRPr sz="771"/>
            </a:lvl5pPr>
            <a:lvl6pPr marL="1759610" indent="0">
              <a:buNone/>
              <a:defRPr sz="771"/>
            </a:lvl6pPr>
            <a:lvl7pPr marL="2111532" indent="0">
              <a:buNone/>
              <a:defRPr sz="771"/>
            </a:lvl7pPr>
            <a:lvl8pPr marL="2463455" indent="0">
              <a:buNone/>
              <a:defRPr sz="771"/>
            </a:lvl8pPr>
            <a:lvl9pPr marL="2815377" indent="0">
              <a:buNone/>
              <a:defRPr sz="77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9803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246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2462"/>
            </a:lvl1pPr>
            <a:lvl2pPr marL="351922" indent="0">
              <a:buNone/>
              <a:defRPr sz="2156"/>
            </a:lvl2pPr>
            <a:lvl3pPr marL="703844" indent="0">
              <a:buNone/>
              <a:defRPr sz="1847"/>
            </a:lvl3pPr>
            <a:lvl4pPr marL="1055766" indent="0">
              <a:buNone/>
              <a:defRPr sz="1539"/>
            </a:lvl4pPr>
            <a:lvl5pPr marL="1407688" indent="0">
              <a:buNone/>
              <a:defRPr sz="1539"/>
            </a:lvl5pPr>
            <a:lvl6pPr marL="1759610" indent="0">
              <a:buNone/>
              <a:defRPr sz="1539"/>
            </a:lvl6pPr>
            <a:lvl7pPr marL="2111532" indent="0">
              <a:buNone/>
              <a:defRPr sz="1539"/>
            </a:lvl7pPr>
            <a:lvl8pPr marL="2463455" indent="0">
              <a:buNone/>
              <a:defRPr sz="1539"/>
            </a:lvl8pPr>
            <a:lvl9pPr marL="2815377" indent="0">
              <a:buNone/>
              <a:defRPr sz="15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233"/>
            </a:lvl1pPr>
            <a:lvl2pPr marL="351922" indent="0">
              <a:buNone/>
              <a:defRPr sz="1077"/>
            </a:lvl2pPr>
            <a:lvl3pPr marL="703844" indent="0">
              <a:buNone/>
              <a:defRPr sz="924"/>
            </a:lvl3pPr>
            <a:lvl4pPr marL="1055766" indent="0">
              <a:buNone/>
              <a:defRPr sz="771"/>
            </a:lvl4pPr>
            <a:lvl5pPr marL="1407688" indent="0">
              <a:buNone/>
              <a:defRPr sz="771"/>
            </a:lvl5pPr>
            <a:lvl6pPr marL="1759610" indent="0">
              <a:buNone/>
              <a:defRPr sz="771"/>
            </a:lvl6pPr>
            <a:lvl7pPr marL="2111532" indent="0">
              <a:buNone/>
              <a:defRPr sz="771"/>
            </a:lvl7pPr>
            <a:lvl8pPr marL="2463455" indent="0">
              <a:buNone/>
              <a:defRPr sz="771"/>
            </a:lvl8pPr>
            <a:lvl9pPr marL="2815377" indent="0">
              <a:buNone/>
              <a:defRPr sz="77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3344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25FE64-A046-4A0C-AD17-7D6764F1933D}" type="datetimeFigureOut">
              <a:rPr lang="zh-CN" altLang="en-US" smtClean="0"/>
              <a:t>202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32C44-4536-4692-97A2-FF81F56981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032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03844" rtl="0" eaLnBrk="1" latinLnBrk="0" hangingPunct="1">
        <a:lnSpc>
          <a:spcPct val="90000"/>
        </a:lnSpc>
        <a:spcBef>
          <a:spcPct val="0"/>
        </a:spcBef>
        <a:buNone/>
        <a:defRPr sz="33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5961" indent="-175961" algn="l" defTabSz="703844" rtl="0" eaLnBrk="1" latinLnBrk="0" hangingPunct="1">
        <a:lnSpc>
          <a:spcPct val="90000"/>
        </a:lnSpc>
        <a:spcBef>
          <a:spcPts val="771"/>
        </a:spcBef>
        <a:buFont typeface="Arial" panose="020B0604020202020204" pitchFamily="34" charset="0"/>
        <a:buChar char="•"/>
        <a:defRPr sz="2156" kern="1200">
          <a:solidFill>
            <a:schemeClr val="tx1"/>
          </a:solidFill>
          <a:latin typeface="+mn-lt"/>
          <a:ea typeface="+mn-ea"/>
          <a:cs typeface="+mn-cs"/>
        </a:defRPr>
      </a:lvl1pPr>
      <a:lvl2pPr marL="527883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847" kern="1200">
          <a:solidFill>
            <a:schemeClr val="tx1"/>
          </a:solidFill>
          <a:latin typeface="+mn-lt"/>
          <a:ea typeface="+mn-ea"/>
          <a:cs typeface="+mn-cs"/>
        </a:defRPr>
      </a:lvl2pPr>
      <a:lvl3pPr marL="879805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539" kern="1200">
          <a:solidFill>
            <a:schemeClr val="tx1"/>
          </a:solidFill>
          <a:latin typeface="+mn-lt"/>
          <a:ea typeface="+mn-ea"/>
          <a:cs typeface="+mn-cs"/>
        </a:defRPr>
      </a:lvl3pPr>
      <a:lvl4pPr marL="1231727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4pPr>
      <a:lvl5pPr marL="1583649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5pPr>
      <a:lvl6pPr marL="1935571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6pPr>
      <a:lvl7pPr marL="2287494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7pPr>
      <a:lvl8pPr marL="2639416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8pPr>
      <a:lvl9pPr marL="2991338" indent="-175961" algn="l" defTabSz="703844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1pPr>
      <a:lvl2pPr marL="351922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2pPr>
      <a:lvl3pPr marL="703844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3pPr>
      <a:lvl4pPr marL="1055766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4pPr>
      <a:lvl5pPr marL="1407688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5pPr>
      <a:lvl6pPr marL="1759610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6pPr>
      <a:lvl7pPr marL="2111532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7pPr>
      <a:lvl8pPr marL="2463455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8pPr>
      <a:lvl9pPr marL="2815377" algn="l" defTabSz="703844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1FC995D-10C9-7AE9-7280-E31D2B1EC8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1346" y="1611368"/>
            <a:ext cx="3458222" cy="2305481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F690A5A5-B47D-0ED4-A422-180034D07987}"/>
              </a:ext>
            </a:extLst>
          </p:cNvPr>
          <p:cNvGrpSpPr/>
          <p:nvPr/>
        </p:nvGrpSpPr>
        <p:grpSpPr>
          <a:xfrm>
            <a:off x="447675" y="1611368"/>
            <a:ext cx="3458222" cy="2305481"/>
            <a:chOff x="447675" y="1611368"/>
            <a:chExt cx="3458222" cy="2305481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883CF528-47F0-57C4-924A-3C6536A20119}"/>
                </a:ext>
              </a:extLst>
            </p:cNvPr>
            <p:cNvGrpSpPr/>
            <p:nvPr/>
          </p:nvGrpSpPr>
          <p:grpSpPr>
            <a:xfrm>
              <a:off x="447675" y="1611368"/>
              <a:ext cx="3458222" cy="2305481"/>
              <a:chOff x="447675" y="1611368"/>
              <a:chExt cx="3458222" cy="2305481"/>
            </a:xfrm>
          </p:grpSpPr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3F2F91C5-67EF-898D-DEA3-33765780F8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7675" y="1611368"/>
                <a:ext cx="3458222" cy="2305481"/>
              </a:xfrm>
              <a:prstGeom prst="rect">
                <a:avLst/>
              </a:prstGeom>
            </p:spPr>
          </p:pic>
          <p:sp>
            <p:nvSpPr>
              <p:cNvPr id="6" name="矩形 5">
                <a:extLst>
                  <a:ext uri="{FF2B5EF4-FFF2-40B4-BE49-F238E27FC236}">
                    <a16:creationId xmlns:a16="http://schemas.microsoft.com/office/drawing/2014/main" id="{1A29B62E-29B0-1847-1912-50BD9553AFE7}"/>
                  </a:ext>
                </a:extLst>
              </p:cNvPr>
              <p:cNvSpPr/>
              <p:nvPr/>
            </p:nvSpPr>
            <p:spPr>
              <a:xfrm rot="20654668">
                <a:off x="1163183" y="3511318"/>
                <a:ext cx="553674" cy="16778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C5C5D529-1A36-7D96-E4A4-5DF6B9961EF6}"/>
                </a:ext>
              </a:extLst>
            </p:cNvPr>
            <p:cNvCxnSpPr>
              <a:cxnSpLocks/>
            </p:cNvCxnSpPr>
            <p:nvPr/>
          </p:nvCxnSpPr>
          <p:spPr>
            <a:xfrm>
              <a:off x="3443287" y="3749384"/>
              <a:ext cx="237600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36720740-B4C6-C766-6805-4F547E3BE57D}"/>
              </a:ext>
            </a:extLst>
          </p:cNvPr>
          <p:cNvGrpSpPr/>
          <p:nvPr/>
        </p:nvGrpSpPr>
        <p:grpSpPr>
          <a:xfrm>
            <a:off x="3905897" y="1611368"/>
            <a:ext cx="3458222" cy="2305481"/>
            <a:chOff x="3905897" y="1611368"/>
            <a:chExt cx="3458222" cy="230548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0235123E-7FF9-E265-43D1-07A53B6C636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05897" y="1611368"/>
              <a:ext cx="3458222" cy="2305481"/>
            </a:xfrm>
            <a:prstGeom prst="rect">
              <a:avLst/>
            </a:prstGeom>
          </p:spPr>
        </p:pic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06B1F396-A69D-022B-0877-72EBA93F2391}"/>
                </a:ext>
              </a:extLst>
            </p:cNvPr>
            <p:cNvCxnSpPr>
              <a:cxnSpLocks/>
            </p:cNvCxnSpPr>
            <p:nvPr/>
          </p:nvCxnSpPr>
          <p:spPr>
            <a:xfrm>
              <a:off x="7005637" y="3816059"/>
              <a:ext cx="237600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F16E7649-2FDD-4CD4-EDAF-D3B9910FD999}"/>
              </a:ext>
            </a:extLst>
          </p:cNvPr>
          <p:cNvSpPr txBox="1"/>
          <p:nvPr/>
        </p:nvSpPr>
        <p:spPr>
          <a:xfrm>
            <a:off x="1983287" y="4956376"/>
            <a:ext cx="8225425" cy="10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263942">
              <a:lnSpc>
                <a:spcPct val="150000"/>
              </a:lnSpc>
            </a:pP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1 Leaf anatomical structure of HX3 and </a:t>
            </a:r>
            <a:r>
              <a:rPr lang="en-US" altLang="zh-CN" sz="1400" i="1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l</a:t>
            </a:r>
            <a:r>
              <a:rPr lang="en-US" altLang="zh-CN" sz="1400" i="1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fter 6-BA treatment. Blade cross-section of HX3 (A) and </a:t>
            </a:r>
            <a:r>
              <a:rPr lang="en-US" altLang="zh-CN" sz="1400" i="1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l</a:t>
            </a:r>
            <a:r>
              <a:rPr lang="en-US" altLang="zh-CN" sz="1400" i="1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. (C) Cell area of epidermis. Data are mean ±SD, n=30. Scale bar represents 10 </a:t>
            </a:r>
            <a:r>
              <a:rPr lang="el-GR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. Different letters denote significant difference at </a:t>
            </a:r>
            <a:r>
              <a:rPr lang="en-US" altLang="zh-CN" sz="1400" i="1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=0.05 level.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5024D3B-032B-60FC-112C-906260630E27}"/>
              </a:ext>
            </a:extLst>
          </p:cNvPr>
          <p:cNvSpPr txBox="1"/>
          <p:nvPr/>
        </p:nvSpPr>
        <p:spPr>
          <a:xfrm>
            <a:off x="447675" y="1611368"/>
            <a:ext cx="289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0ABC0A7-2F17-5AAE-D81C-9D394E3CDAFE}"/>
              </a:ext>
            </a:extLst>
          </p:cNvPr>
          <p:cNvSpPr txBox="1"/>
          <p:nvPr/>
        </p:nvSpPr>
        <p:spPr>
          <a:xfrm>
            <a:off x="3905897" y="1611368"/>
            <a:ext cx="289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8CE2AA5-A792-CA58-74BC-662B93A28B7E}"/>
              </a:ext>
            </a:extLst>
          </p:cNvPr>
          <p:cNvSpPr txBox="1"/>
          <p:nvPr/>
        </p:nvSpPr>
        <p:spPr>
          <a:xfrm>
            <a:off x="7721346" y="1611368"/>
            <a:ext cx="289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8713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8E89E7C-F97F-1199-5E5F-73F6E2F041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5003" y="0"/>
            <a:ext cx="2671572" cy="314325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9B0179B-238C-1080-C6D0-5E27CCEAA85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2190" y="0"/>
            <a:ext cx="2598420" cy="31432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58058C8-D006-B25A-D28F-7B7EBD5386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6225" y="0"/>
            <a:ext cx="2671572" cy="31432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C08F3E2-DB26-38F0-128E-19287DF195D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5229" y="3143250"/>
            <a:ext cx="2598420" cy="31432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7B98DB2-3160-0B30-9D9E-A8BD496F05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226" y="3143250"/>
            <a:ext cx="2671572" cy="314325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5CEC30B-0750-4A0F-3748-66129C62A8DE}"/>
              </a:ext>
            </a:extLst>
          </p:cNvPr>
          <p:cNvSpPr txBox="1"/>
          <p:nvPr/>
        </p:nvSpPr>
        <p:spPr>
          <a:xfrm>
            <a:off x="2246677" y="6405860"/>
            <a:ext cx="8225425" cy="700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263942">
              <a:lnSpc>
                <a:spcPct val="150000"/>
              </a:lnSpc>
            </a:pP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2 Expression level of </a:t>
            </a:r>
            <a:r>
              <a:rPr lang="en-US" altLang="zh-CN" sz="1400" i="1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KX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after 6-BA treatment in HX3 and </a:t>
            </a:r>
            <a:r>
              <a:rPr lang="en-US" altLang="zh-CN" sz="1400" i="1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l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Different letters indicate significantly difference at </a:t>
            </a:r>
            <a:r>
              <a:rPr lang="en-US" altLang="zh-CN" sz="1400" i="1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=0.05 level. </a:t>
            </a:r>
          </a:p>
        </p:txBody>
      </p:sp>
    </p:spTree>
    <p:extLst>
      <p:ext uri="{BB962C8B-B14F-4D97-AF65-F5344CB8AC3E}">
        <p14:creationId xmlns:p14="http://schemas.microsoft.com/office/powerpoint/2010/main" val="29690719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401559" y="5104040"/>
            <a:ext cx="8225425" cy="3768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263942">
              <a:lnSpc>
                <a:spcPct val="150000"/>
              </a:lnSpc>
            </a:pP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3 Expression level of 15 genes that regulated leaf development in soybean of HX3 and </a:t>
            </a:r>
            <a:r>
              <a:rPr lang="en-US" altLang="zh-CN" sz="1400" i="1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l</a:t>
            </a:r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5703" y="617297"/>
            <a:ext cx="5220593" cy="416456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1_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7</TotalTime>
  <Words>111</Words>
  <Application>Microsoft Office PowerPoint</Application>
  <PresentationFormat>宽屏</PresentationFormat>
  <Paragraphs>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1_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晓敏 许</dc:creator>
  <cp:lastModifiedBy>晓敏 许</cp:lastModifiedBy>
  <cp:revision>9</cp:revision>
  <dcterms:created xsi:type="dcterms:W3CDTF">2024-02-23T01:38:04Z</dcterms:created>
  <dcterms:modified xsi:type="dcterms:W3CDTF">2024-05-28T14:15:36Z</dcterms:modified>
</cp:coreProperties>
</file>